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8" r:id="rId2"/>
    <p:sldId id="269" r:id="rId3"/>
    <p:sldId id="270" r:id="rId4"/>
    <p:sldId id="271" r:id="rId5"/>
    <p:sldId id="272" r:id="rId6"/>
    <p:sldId id="273" r:id="rId7"/>
    <p:sldId id="274" r:id="rId8"/>
    <p:sldId id="261" r:id="rId9"/>
    <p:sldId id="262" r:id="rId10"/>
    <p:sldId id="267" r:id="rId11"/>
    <p:sldId id="263" r:id="rId12"/>
    <p:sldId id="275" r:id="rId13"/>
    <p:sldId id="276" r:id="rId14"/>
    <p:sldId id="265" r:id="rId1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07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5E3344-BE90-4ABE-92A8-6C67F6968461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03B208-6581-4708-BC84-38EBE6B295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454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03B208-6581-4708-BC84-38EBE6B29561}" type="slidenum">
              <a:rPr lang="en-US" smtClean="0"/>
              <a:pPr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457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 l="8750" t="10000" r="3125" b="12222"/>
          <a:stretch>
            <a:fillRect/>
          </a:stretch>
        </p:blipFill>
        <p:spPr bwMode="auto">
          <a:xfrm>
            <a:off x="40547" y="1219199"/>
            <a:ext cx="9055828" cy="4495801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6" name="Rectangle 5"/>
          <p:cNvSpPr/>
          <p:nvPr/>
        </p:nvSpPr>
        <p:spPr>
          <a:xfrm>
            <a:off x="4260297" y="621268"/>
            <a:ext cx="8451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R: 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90600" y="6248400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</a:t>
            </a:r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810000" y="762000"/>
            <a:ext cx="12044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 S: T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/>
          <a:srcRect l="8125" t="8889" b="10000"/>
          <a:stretch>
            <a:fillRect/>
          </a:stretch>
        </p:blipFill>
        <p:spPr bwMode="auto">
          <a:xfrm>
            <a:off x="0" y="1174102"/>
            <a:ext cx="9144000" cy="4540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990600" y="6248400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27261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429000" y="762000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. S: M-d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/>
          <a:srcRect l="8125" t="10000" r="1250" b="10000"/>
          <a:stretch>
            <a:fillRect/>
          </a:stretch>
        </p:blipFill>
        <p:spPr bwMode="auto">
          <a:xfrm>
            <a:off x="42942" y="1143000"/>
            <a:ext cx="9054042" cy="449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990600" y="6248400"/>
            <a:ext cx="362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69300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733800" y="621268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. S: T-d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/>
          <a:srcRect l="6875" t="8889" r="13125" b="20000"/>
          <a:stretch>
            <a:fillRect/>
          </a:stretch>
        </p:blipFill>
        <p:spPr bwMode="auto">
          <a:xfrm>
            <a:off x="0" y="9906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990600" y="62484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II</a:t>
            </a:r>
            <a:endParaRPr 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733800" y="621268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. S: M-d5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/>
          <a:srcRect l="8125" t="8889" r="1250" b="11111"/>
          <a:stretch>
            <a:fillRect/>
          </a:stretch>
        </p:blipFill>
        <p:spPr bwMode="auto">
          <a:xfrm>
            <a:off x="17832" y="990600"/>
            <a:ext cx="9067800" cy="45026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990600" y="6248400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III</a:t>
            </a:r>
            <a:endParaRPr 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657600" y="392869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. S: T-d5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200" y="5257800"/>
            <a:ext cx="89916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upplementary file 1, (I-XIV)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Mass spectrometry analysis (HPLC/MS, Agilent 1,200 series, Agilent Technologies) of leaf samples from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lack rot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 line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CNU-C-4072 (1-7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and S line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CNU-C-3383 (8-14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of cabbage under different treatments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, control; 1DM, 1 day mock; 1DT, 1 day treated; 3DM, 3 day mock; 3DT, 3 day treated; 5DM, 5 day mock; 5 DT, 5 day treated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was used to identify individual GSLs . R: Resistant; S: Susceptible.</a:t>
            </a:r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3"/>
          <a:srcRect l="8125" t="8889" r="1250" b="11111"/>
          <a:stretch>
            <a:fillRect/>
          </a:stretch>
        </p:blipFill>
        <p:spPr bwMode="auto">
          <a:xfrm>
            <a:off x="27560" y="727608"/>
            <a:ext cx="9067800" cy="45026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8382000" y="609600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I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8963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 l="2500" t="8889" r="13605" b="16667"/>
          <a:stretch>
            <a:fillRect/>
          </a:stretch>
        </p:blipFill>
        <p:spPr bwMode="auto">
          <a:xfrm>
            <a:off x="113874" y="1295400"/>
            <a:ext cx="8953926" cy="446925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4038600" y="609600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R: M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90600" y="62484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I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962400" y="796836"/>
            <a:ext cx="106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R:T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 l="8125" t="10000" r="1250" b="11111"/>
          <a:stretch>
            <a:fillRect/>
          </a:stretch>
        </p:blipFill>
        <p:spPr bwMode="auto">
          <a:xfrm>
            <a:off x="25936" y="1188383"/>
            <a:ext cx="9088879" cy="4450417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990600" y="6248400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II</a:t>
            </a:r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897439" y="685800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R: M-d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 l="8125" t="8889" r="1250" b="12222"/>
          <a:stretch>
            <a:fillRect/>
          </a:stretch>
        </p:blipFill>
        <p:spPr bwMode="auto">
          <a:xfrm>
            <a:off x="61312" y="1104088"/>
            <a:ext cx="9025944" cy="44196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990600" y="6248400"/>
            <a:ext cx="373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V</a:t>
            </a:r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976324" y="762000"/>
            <a:ext cx="11147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R: T-d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 l="8125" t="8889" r="1250" b="11111"/>
          <a:stretch>
            <a:fillRect/>
          </a:stretch>
        </p:blipFill>
        <p:spPr bwMode="auto">
          <a:xfrm>
            <a:off x="6480" y="1189490"/>
            <a:ext cx="9108336" cy="452276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990600" y="6248400"/>
            <a:ext cx="316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</a:t>
            </a:r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 l="6250" t="11111" r="13125" b="18889"/>
          <a:stretch>
            <a:fillRect/>
          </a:stretch>
        </p:blipFill>
        <p:spPr bwMode="auto">
          <a:xfrm>
            <a:off x="28575" y="1266825"/>
            <a:ext cx="9049657" cy="44196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3976324" y="762000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R: M-d5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90600" y="6248400"/>
            <a:ext cx="373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I</a:t>
            </a:r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976324" y="685800"/>
            <a:ext cx="11147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R: T-d5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 l="5000" t="10000" r="13125" b="17778"/>
          <a:stretch>
            <a:fillRect/>
          </a:stretch>
        </p:blipFill>
        <p:spPr bwMode="auto">
          <a:xfrm>
            <a:off x="9525" y="1066799"/>
            <a:ext cx="9124950" cy="4527647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990600" y="6248400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II</a:t>
            </a:r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733800" y="762000"/>
            <a:ext cx="8194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S: 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 l="5000" t="10000" r="13125" b="17778"/>
          <a:stretch>
            <a:fillRect/>
          </a:stretch>
        </p:blipFill>
        <p:spPr bwMode="auto">
          <a:xfrm>
            <a:off x="35607" y="1143000"/>
            <a:ext cx="9060767" cy="449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990600" y="624840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II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82803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423565" y="762000"/>
            <a:ext cx="11785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 S: M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 l="7500" t="8889" r="13125" b="21111"/>
          <a:stretch>
            <a:fillRect/>
          </a:stretch>
        </p:blipFill>
        <p:spPr bwMode="auto">
          <a:xfrm>
            <a:off x="19049" y="1142999"/>
            <a:ext cx="9115425" cy="452182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990600" y="6248400"/>
            <a:ext cx="362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8992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5</TotalTime>
  <Words>184</Words>
  <Application>Microsoft Office PowerPoint</Application>
  <PresentationFormat>On-screen Show (4:3)</PresentationFormat>
  <Paragraphs>30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Ujjal Kumar nath</cp:lastModifiedBy>
  <cp:revision>23</cp:revision>
  <dcterms:created xsi:type="dcterms:W3CDTF">2006-08-16T00:00:00Z</dcterms:created>
  <dcterms:modified xsi:type="dcterms:W3CDTF">2020-05-04T12:58:33Z</dcterms:modified>
</cp:coreProperties>
</file>